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4" d="100"/>
          <a:sy n="64" d="100"/>
        </p:scale>
        <p:origin x="748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1E959F-2226-4196-8545-392CFF08AA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D48196F-E301-47A9-A814-CE0BBC8007B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9F726B-CEEF-431B-8C3A-88BE0E9ABB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8A07F9-E24B-42A2-81F4-597879CB2909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6DBD43-DDC3-41E4-9B13-DC2BA83A6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6C3C94-633F-41AB-BD1F-B6C692B1AA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D3704-7131-4EAD-8683-CCBDD19AA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864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1AF02-1E20-4438-AFFA-CB3E1669E0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992DD75-BFFB-4821-9C7D-40095A0234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7B679A-7F26-4F28-9CDA-33CC53E770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8A07F9-E24B-42A2-81F4-597879CB2909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5E1915-56F9-4784-9829-191D74C2A0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CB984D-CE18-45B4-8C5D-4E7E579246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D3704-7131-4EAD-8683-CCBDD19AA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7750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3B0AB1E-3585-4482-B8DD-CDBE419CEE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EC1E339-FEF4-4905-8B6A-D2951A7D0A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00CEC7-CAA4-415B-87B0-B15E3DD160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8A07F9-E24B-42A2-81F4-597879CB2909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F5054F-ECE9-4D63-9978-0F26A99D95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1A0B9D-7CBD-49FE-8540-C6EF48C9C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D3704-7131-4EAD-8683-CCBDD19AA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06785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ADA12C-58FC-440F-A51A-1496E28C09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46DB89-8299-447B-A7BB-EC2CABB2AC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3F3F6A-3746-4E9D-8D93-0445EC7611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8A07F9-E24B-42A2-81F4-597879CB2909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CB61BC-9E90-4559-8AD6-117FF55AE2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FEA9E1-B51C-4D71-8440-15A5092802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D3704-7131-4EAD-8683-CCBDD19AA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963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39E7E7-35F3-4BCB-B8AB-B121E895A4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6FA477-4CC1-4369-AE18-A330ABD07C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64F607-BAD3-47C3-A3C6-1FC708BDF1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8A07F9-E24B-42A2-81F4-597879CB2909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B7C42F-A05D-4917-95E8-C8D4043FA5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FBF521-1D06-4DE3-A658-A0EB3DBA7A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D3704-7131-4EAD-8683-CCBDD19AA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8512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38988A-F845-4917-8819-09C27404CB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8FEBBC-9465-4F5F-818C-A0AEE54A643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253508F-D477-4B73-840A-7D1564556F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63E5E2-5DC6-4D55-8438-BB173277C7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8A07F9-E24B-42A2-81F4-597879CB2909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8B3191-E7AA-4A57-9494-3D83F96AF6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F48DF6-3EB8-46E6-BB27-A606B4DF27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D3704-7131-4EAD-8683-CCBDD19AA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0245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C47C8E-EEDD-466F-94A3-A30DC48DE0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2A4CC4-35DA-420C-B5CA-1E91F2D736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90E2FE-D63A-4331-9683-B1F7AF6BE5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B154510-E074-4E36-B188-9CAAE29290C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2A81897-AF55-473A-82BD-BADD547D767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E849F50-2691-464C-80C7-BD1D3B950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8A07F9-E24B-42A2-81F4-597879CB2909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1B23C1F-C4C5-4D88-B9FF-7B0F6DDC57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1EED5DE-6264-46B0-8F81-531F4E6962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D3704-7131-4EAD-8683-CCBDD19AA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1118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507CBA-DD9C-4DAD-A4CD-251F142D94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C53A4D5-7197-4317-8337-A8B60BDC7F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8A07F9-E24B-42A2-81F4-597879CB2909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2D99CED-DDB4-41E4-B040-9B865D0478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4F8DC22-2009-47DF-8C96-DB280BCED8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D3704-7131-4EAD-8683-CCBDD19AA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9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6C5EAED-EACE-4EF7-8043-208E7C10B9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8A07F9-E24B-42A2-81F4-597879CB2909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A7C04C-5A07-4A7C-A7D0-4292647F53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5EAC202-EA5D-4F6F-AA11-77D2D6B4EB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D3704-7131-4EAD-8683-CCBDD19AA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06806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983373-DB7F-49E2-BD16-52ACB20CEE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850171-4434-490A-AA23-F5476B3F2CF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F557814-5B08-4F41-8F4E-C1A08EBB8E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99D3CE-13D5-4B9D-AF44-88103D862E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8A07F9-E24B-42A2-81F4-597879CB2909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715DA9-D17D-4A66-AAC7-36948F8A44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15B414-51B4-426C-88E8-8FF429E59B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D3704-7131-4EAD-8683-CCBDD19AA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7895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C6EA90-4D48-4219-8CC2-F3CFFC4FBF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9273036-CC88-4B05-BA06-5DD2EDF0045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D10CB75-8642-459D-B4C2-9D8D220F5D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E90848-5B1B-4718-BBBE-325183417B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8A07F9-E24B-42A2-81F4-597879CB2909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39DB68-9136-40E7-936C-714541C38E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1321BE-60BF-4476-8217-505D6FDA48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D3704-7131-4EAD-8683-CCBDD19AA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381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B173337-03CD-444B-899E-069D876418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FD1F7F-F96D-4716-A31F-82C3FA1B7A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F7F7C2-55E2-4F75-A52C-5D80F86BE40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8A07F9-E24B-42A2-81F4-597879CB2909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05D53D-BFC2-4194-9032-B0DFCAC9C03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FBE650-B7EB-480E-99D1-753AB44C27E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CD3704-7131-4EAD-8683-CCBDD19AA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72079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3AA63E8A-C9B0-4636-AA76-55D1986D12B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05045226"/>
              </p:ext>
            </p:extLst>
          </p:nvPr>
        </p:nvGraphicFramePr>
        <p:xfrm>
          <a:off x="2645603" y="1024303"/>
          <a:ext cx="5708100" cy="240469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154997">
                  <a:extLst>
                    <a:ext uri="{9D8B030D-6E8A-4147-A177-3AD203B41FA5}">
                      <a16:colId xmlns:a16="http://schemas.microsoft.com/office/drawing/2014/main" val="925832701"/>
                    </a:ext>
                  </a:extLst>
                </a:gridCol>
                <a:gridCol w="1798983">
                  <a:extLst>
                    <a:ext uri="{9D8B030D-6E8A-4147-A177-3AD203B41FA5}">
                      <a16:colId xmlns:a16="http://schemas.microsoft.com/office/drawing/2014/main" val="900379159"/>
                    </a:ext>
                  </a:extLst>
                </a:gridCol>
                <a:gridCol w="1754120">
                  <a:extLst>
                    <a:ext uri="{9D8B030D-6E8A-4147-A177-3AD203B41FA5}">
                      <a16:colId xmlns:a16="http://schemas.microsoft.com/office/drawing/2014/main" val="3954183593"/>
                    </a:ext>
                  </a:extLst>
                </a:gridCol>
              </a:tblGrid>
              <a:tr h="26460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Gene Name </a:t>
                      </a: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572" marR="5857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Forward Primer (5’</a:t>
                      </a: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sym typeface="Wingdings" panose="05000000000000000000" pitchFamily="2" charset="2"/>
                        </a:rPr>
                        <a:t> 3’)</a:t>
                      </a: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572" marR="5857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Reverse Primer </a:t>
                      </a: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</a:rPr>
                        <a:t>(5’</a:t>
                      </a: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sym typeface="Wingdings" panose="05000000000000000000" pitchFamily="2" charset="2"/>
                        </a:rPr>
                        <a:t> 3’)</a:t>
                      </a: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572" marR="5857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5196667"/>
                  </a:ext>
                </a:extLst>
              </a:tr>
              <a:tr h="26460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GAPDH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572" marR="5857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CATGTTCCAGTATGACTCCACTC</a:t>
                      </a: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572" marR="5857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GGCCTCACCCCATTTGATGT</a:t>
                      </a: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572" marR="5857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4633592"/>
                  </a:ext>
                </a:extLst>
              </a:tr>
              <a:tr h="32872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Complement C4A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572" marR="5857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GATGACAAGAACGTGAGTGTCC</a:t>
                      </a: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572" marR="5857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CCCTTTAGCCACCAATTTCAGG</a:t>
                      </a: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572" marR="5857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45433875"/>
                  </a:ext>
                </a:extLst>
              </a:tr>
              <a:tr h="29817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interleukin 1β (IL-1β)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572" marR="5857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TTCAGGCAGGCAGTATCACTC</a:t>
                      </a: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572" marR="5857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GAAGGTCCACGGGAAAGACAC</a:t>
                      </a: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572" marR="5857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3550749"/>
                  </a:ext>
                </a:extLst>
              </a:tr>
              <a:tr h="357808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interleukin 6 (IL-6)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572" marR="5857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TCTATACCACTTCACAAGTCGGA</a:t>
                      </a: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572" marR="5857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GAATTGCCATTGCACAACTCTTT</a:t>
                      </a: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572" marR="5857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36547869"/>
                  </a:ext>
                </a:extLst>
              </a:tr>
              <a:tr h="626166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ionized calcium-binding adaptor molecule 1 (IBA1)</a:t>
                      </a: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572" marR="5857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ATCAACAAGCAATTCCTCGATGA</a:t>
                      </a: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572" marR="5857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CAGCATTCGCTTCAAGGACATA</a:t>
                      </a: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572" marR="5857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87397212"/>
                  </a:ext>
                </a:extLst>
              </a:tr>
              <a:tr h="264607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GSK3β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572" marR="5857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ACAGGCCACAGGAGGTCAGT</a:t>
                      </a: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572" marR="5857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GATGGCAACCAGTTCTCCAG</a:t>
                      </a: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572" marR="5857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540064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266607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52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njamin Sachs</dc:creator>
  <cp:lastModifiedBy>Benjamin Sachs</cp:lastModifiedBy>
  <cp:revision>1</cp:revision>
  <dcterms:created xsi:type="dcterms:W3CDTF">2021-04-29T20:09:16Z</dcterms:created>
  <dcterms:modified xsi:type="dcterms:W3CDTF">2021-04-29T20:14:31Z</dcterms:modified>
</cp:coreProperties>
</file>